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ngesInfos/changesInfo1.xml" ContentType="application/vnd.ms-powerpoint.changesinfo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4"/>
  </p:sldMasterIdLst>
  <p:sldIdLst>
    <p:sldId id="270" r:id="rId5"/>
    <p:sldId id="273" r:id="rId6"/>
    <p:sldId id="272" r:id="rId7"/>
    <p:sldId id="269" r:id="rId8"/>
    <p:sldId id="271" r:id="rId9"/>
    <p:sldId id="268" r:id="rId10"/>
  </p:sldIdLst>
  <p:sldSz cx="7772400" cy="100584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>
  <p1510:revLst>
    <p1510:client id="{08F8FC5A-8788-044C-84F8-C21BC4796075}" v="28" dt="2022-07-09T01:08:24.236"/>
    <p1510:client id="{3B498B3E-C296-4D0D-92B0-1ABA3B04A5CE}" v="18" dt="2022-07-31T20:06:41.577"/>
    <p1510:client id="{92387258-633B-4425-A550-DBB2668B2A5C}" v="757" dt="2022-07-10T04:18:46.603"/>
  </p1510:revLst>
</p1510:revInfo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47" d="100"/>
          <a:sy n="47" d="100"/>
        </p:scale>
        <p:origin x="2244" y="4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theme" Target="theme/theme1.xml"/><Relationship Id="rId3" Type="http://schemas.openxmlformats.org/officeDocument/2006/relationships/customXml" Target="../customXml/item3.xml"/><Relationship Id="rId7" Type="http://schemas.openxmlformats.org/officeDocument/2006/relationships/slide" Target="slides/slide3.xml"/><Relationship Id="rId12" Type="http://schemas.openxmlformats.org/officeDocument/2006/relationships/viewProps" Target="viewProps.xml"/><Relationship Id="rId2" Type="http://schemas.openxmlformats.org/officeDocument/2006/relationships/customXml" Target="../customXml/item2.xml"/><Relationship Id="rId16" Type="http://schemas.microsoft.com/office/2015/10/relationships/revisionInfo" Target="revisionInfo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presProps" Target="presProps.xml"/><Relationship Id="rId5" Type="http://schemas.openxmlformats.org/officeDocument/2006/relationships/slide" Target="slides/slide1.xml"/><Relationship Id="rId15" Type="http://schemas.microsoft.com/office/2016/11/relationships/changesInfo" Target="changesInfos/changesInfo1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tableStyles" Target="tableStyle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Brandon Lam" userId="S::blam2_stanford.edu#ext#@livejohnshopkins.onmicrosoft.com::08e98292-3b1e-4ec9-b05d-adf5d475184d" providerId="AD" clId="Web-{92387258-633B-4425-A550-DBB2668B2A5C}"/>
    <pc:docChg chg="modSld">
      <pc:chgData name="Brandon Lam" userId="S::blam2_stanford.edu#ext#@livejohnshopkins.onmicrosoft.com::08e98292-3b1e-4ec9-b05d-adf5d475184d" providerId="AD" clId="Web-{92387258-633B-4425-A550-DBB2668B2A5C}" dt="2022-07-10T04:18:46.603" v="387" actId="20577"/>
      <pc:docMkLst>
        <pc:docMk/>
      </pc:docMkLst>
      <pc:sldChg chg="modSp">
        <pc:chgData name="Brandon Lam" userId="S::blam2_stanford.edu#ext#@livejohnshopkins.onmicrosoft.com::08e98292-3b1e-4ec9-b05d-adf5d475184d" providerId="AD" clId="Web-{92387258-633B-4425-A550-DBB2668B2A5C}" dt="2022-07-10T04:18:46.603" v="387" actId="20577"/>
        <pc:sldMkLst>
          <pc:docMk/>
          <pc:sldMk cId="2435610282" sldId="268"/>
        </pc:sldMkLst>
        <pc:spChg chg="mod">
          <ac:chgData name="Brandon Lam" userId="S::blam2_stanford.edu#ext#@livejohnshopkins.onmicrosoft.com::08e98292-3b1e-4ec9-b05d-adf5d475184d" providerId="AD" clId="Web-{92387258-633B-4425-A550-DBB2668B2A5C}" dt="2022-07-10T04:18:46.603" v="387" actId="20577"/>
          <ac:spMkLst>
            <pc:docMk/>
            <pc:sldMk cId="2435610282" sldId="268"/>
            <ac:spMk id="7" creationId="{2810DAAB-B671-1245-B6B0-4A299C4C17F2}"/>
          </ac:spMkLst>
        </pc:spChg>
      </pc:sldChg>
      <pc:sldChg chg="modSp">
        <pc:chgData name="Brandon Lam" userId="S::blam2_stanford.edu#ext#@livejohnshopkins.onmicrosoft.com::08e98292-3b1e-4ec9-b05d-adf5d475184d" providerId="AD" clId="Web-{92387258-633B-4425-A550-DBB2668B2A5C}" dt="2022-07-10T04:15:38.739" v="233" actId="20577"/>
        <pc:sldMkLst>
          <pc:docMk/>
          <pc:sldMk cId="3571302438" sldId="271"/>
        </pc:sldMkLst>
        <pc:spChg chg="mod">
          <ac:chgData name="Brandon Lam" userId="S::blam2_stanford.edu#ext#@livejohnshopkins.onmicrosoft.com::08e98292-3b1e-4ec9-b05d-adf5d475184d" providerId="AD" clId="Web-{92387258-633B-4425-A550-DBB2668B2A5C}" dt="2022-07-10T04:15:38.739" v="233" actId="20577"/>
          <ac:spMkLst>
            <pc:docMk/>
            <pc:sldMk cId="3571302438" sldId="271"/>
            <ac:spMk id="9" creationId="{16059D99-1ED9-F4E3-1C3B-745C359E6595}"/>
          </ac:spMkLst>
        </pc:spChg>
      </pc:sldChg>
      <pc:sldChg chg="modSp">
        <pc:chgData name="Brandon Lam" userId="S::blam2_stanford.edu#ext#@livejohnshopkins.onmicrosoft.com::08e98292-3b1e-4ec9-b05d-adf5d475184d" providerId="AD" clId="Web-{92387258-633B-4425-A550-DBB2668B2A5C}" dt="2022-07-10T04:15:02.379" v="217" actId="20577"/>
        <pc:sldMkLst>
          <pc:docMk/>
          <pc:sldMk cId="3092437848" sldId="272"/>
        </pc:sldMkLst>
        <pc:spChg chg="mod">
          <ac:chgData name="Brandon Lam" userId="S::blam2_stanford.edu#ext#@livejohnshopkins.onmicrosoft.com::08e98292-3b1e-4ec9-b05d-adf5d475184d" providerId="AD" clId="Web-{92387258-633B-4425-A550-DBB2668B2A5C}" dt="2022-07-10T04:15:02.379" v="217" actId="20577"/>
          <ac:spMkLst>
            <pc:docMk/>
            <pc:sldMk cId="3092437848" sldId="272"/>
            <ac:spMk id="6" creationId="{C2F5F9E3-8F08-A4DA-B19E-7572E51F0E6A}"/>
          </ac:spMkLst>
        </pc:spChg>
      </pc:sldChg>
    </pc:docChg>
  </pc:docChgLst>
  <pc:docChgLst>
    <pc:chgData name="Ray Kung" userId="f040dff3-2191-46ca-9bbc-8edbf56e8c11" providerId="ADAL" clId="{08F8FC5A-8788-044C-84F8-C21BC4796075}"/>
    <pc:docChg chg="undo custSel addSld modSld sldOrd">
      <pc:chgData name="Ray Kung" userId="f040dff3-2191-46ca-9bbc-8edbf56e8c11" providerId="ADAL" clId="{08F8FC5A-8788-044C-84F8-C21BC4796075}" dt="2022-07-09T01:09:02.496" v="736" actId="1036"/>
      <pc:docMkLst>
        <pc:docMk/>
      </pc:docMkLst>
      <pc:sldChg chg="modSp mod">
        <pc:chgData name="Ray Kung" userId="f040dff3-2191-46ca-9bbc-8edbf56e8c11" providerId="ADAL" clId="{08F8FC5A-8788-044C-84F8-C21BC4796075}" dt="2022-07-08T03:29:52.361" v="334" actId="20577"/>
        <pc:sldMkLst>
          <pc:docMk/>
          <pc:sldMk cId="2435610282" sldId="268"/>
        </pc:sldMkLst>
        <pc:spChg chg="mod">
          <ac:chgData name="Ray Kung" userId="f040dff3-2191-46ca-9bbc-8edbf56e8c11" providerId="ADAL" clId="{08F8FC5A-8788-044C-84F8-C21BC4796075}" dt="2022-07-08T03:29:52.361" v="334" actId="20577"/>
          <ac:spMkLst>
            <pc:docMk/>
            <pc:sldMk cId="2435610282" sldId="268"/>
            <ac:spMk id="7" creationId="{2810DAAB-B671-1245-B6B0-4A299C4C17F2}"/>
          </ac:spMkLst>
        </pc:spChg>
      </pc:sldChg>
      <pc:sldChg chg="modSp mod">
        <pc:chgData name="Ray Kung" userId="f040dff3-2191-46ca-9bbc-8edbf56e8c11" providerId="ADAL" clId="{08F8FC5A-8788-044C-84F8-C21BC4796075}" dt="2022-07-08T03:29:29.085" v="329" actId="20577"/>
        <pc:sldMkLst>
          <pc:docMk/>
          <pc:sldMk cId="2066887279" sldId="269"/>
        </pc:sldMkLst>
        <pc:spChg chg="mod">
          <ac:chgData name="Ray Kung" userId="f040dff3-2191-46ca-9bbc-8edbf56e8c11" providerId="ADAL" clId="{08F8FC5A-8788-044C-84F8-C21BC4796075}" dt="2022-07-08T03:29:29.085" v="329" actId="20577"/>
          <ac:spMkLst>
            <pc:docMk/>
            <pc:sldMk cId="2066887279" sldId="269"/>
            <ac:spMk id="6" creationId="{FDAB2AA7-08B1-DF4B-91E2-D6C7E3242D76}"/>
          </ac:spMkLst>
        </pc:spChg>
      </pc:sldChg>
      <pc:sldChg chg="modSp mod">
        <pc:chgData name="Ray Kung" userId="f040dff3-2191-46ca-9bbc-8edbf56e8c11" providerId="ADAL" clId="{08F8FC5A-8788-044C-84F8-C21BC4796075}" dt="2022-07-08T02:42:17.539" v="96" actId="20577"/>
        <pc:sldMkLst>
          <pc:docMk/>
          <pc:sldMk cId="1684915752" sldId="270"/>
        </pc:sldMkLst>
        <pc:spChg chg="mod">
          <ac:chgData name="Ray Kung" userId="f040dff3-2191-46ca-9bbc-8edbf56e8c11" providerId="ADAL" clId="{08F8FC5A-8788-044C-84F8-C21BC4796075}" dt="2022-07-08T02:42:17.539" v="96" actId="20577"/>
          <ac:spMkLst>
            <pc:docMk/>
            <pc:sldMk cId="1684915752" sldId="270"/>
            <ac:spMk id="2" creationId="{94124976-286D-F343-8F28-68B54D387CC9}"/>
          </ac:spMkLst>
        </pc:spChg>
      </pc:sldChg>
      <pc:sldChg chg="addSp delSp modSp new mod">
        <pc:chgData name="Ray Kung" userId="f040dff3-2191-46ca-9bbc-8edbf56e8c11" providerId="ADAL" clId="{08F8FC5A-8788-044C-84F8-C21BC4796075}" dt="2022-07-08T03:45:20.328" v="684" actId="553"/>
        <pc:sldMkLst>
          <pc:docMk/>
          <pc:sldMk cId="3571302438" sldId="271"/>
        </pc:sldMkLst>
        <pc:spChg chg="del">
          <ac:chgData name="Ray Kung" userId="f040dff3-2191-46ca-9bbc-8edbf56e8c11" providerId="ADAL" clId="{08F8FC5A-8788-044C-84F8-C21BC4796075}" dt="2022-07-08T02:21:36.115" v="1" actId="478"/>
          <ac:spMkLst>
            <pc:docMk/>
            <pc:sldMk cId="3571302438" sldId="271"/>
            <ac:spMk id="2" creationId="{6CCF1CA8-2C9A-2C5D-D05B-821F3DE548B9}"/>
          </ac:spMkLst>
        </pc:spChg>
        <pc:spChg chg="del">
          <ac:chgData name="Ray Kung" userId="f040dff3-2191-46ca-9bbc-8edbf56e8c11" providerId="ADAL" clId="{08F8FC5A-8788-044C-84F8-C21BC4796075}" dt="2022-07-08T02:21:36.993" v="2" actId="478"/>
          <ac:spMkLst>
            <pc:docMk/>
            <pc:sldMk cId="3571302438" sldId="271"/>
            <ac:spMk id="3" creationId="{D4448ECF-65A9-8C54-BAD9-A928D3798FDC}"/>
          </ac:spMkLst>
        </pc:spChg>
        <pc:spChg chg="add mod">
          <ac:chgData name="Ray Kung" userId="f040dff3-2191-46ca-9bbc-8edbf56e8c11" providerId="ADAL" clId="{08F8FC5A-8788-044C-84F8-C21BC4796075}" dt="2022-07-08T03:43:33.122" v="658" actId="113"/>
          <ac:spMkLst>
            <pc:docMk/>
            <pc:sldMk cId="3571302438" sldId="271"/>
            <ac:spMk id="9" creationId="{16059D99-1ED9-F4E3-1C3B-745C359E6595}"/>
          </ac:spMkLst>
        </pc:spChg>
        <pc:spChg chg="add mod">
          <ac:chgData name="Ray Kung" userId="f040dff3-2191-46ca-9bbc-8edbf56e8c11" providerId="ADAL" clId="{08F8FC5A-8788-044C-84F8-C21BC4796075}" dt="2022-07-08T03:45:11.646" v="683" actId="553"/>
          <ac:spMkLst>
            <pc:docMk/>
            <pc:sldMk cId="3571302438" sldId="271"/>
            <ac:spMk id="10" creationId="{08477702-1358-059A-56F4-764318E5A522}"/>
          </ac:spMkLst>
        </pc:spChg>
        <pc:spChg chg="add mod">
          <ac:chgData name="Ray Kung" userId="f040dff3-2191-46ca-9bbc-8edbf56e8c11" providerId="ADAL" clId="{08F8FC5A-8788-044C-84F8-C21BC4796075}" dt="2022-07-08T03:45:20.328" v="684" actId="553"/>
          <ac:spMkLst>
            <pc:docMk/>
            <pc:sldMk cId="3571302438" sldId="271"/>
            <ac:spMk id="11" creationId="{836691CE-7D47-FD98-B5FD-85DDB05D32FE}"/>
          </ac:spMkLst>
        </pc:spChg>
        <pc:spChg chg="add mod">
          <ac:chgData name="Ray Kung" userId="f040dff3-2191-46ca-9bbc-8edbf56e8c11" providerId="ADAL" clId="{08F8FC5A-8788-044C-84F8-C21BC4796075}" dt="2022-07-08T03:44:58.588" v="681" actId="554"/>
          <ac:spMkLst>
            <pc:docMk/>
            <pc:sldMk cId="3571302438" sldId="271"/>
            <ac:spMk id="12" creationId="{D27D2774-0F6B-0D44-75EA-C35F15B81975}"/>
          </ac:spMkLst>
        </pc:spChg>
        <pc:spChg chg="add mod">
          <ac:chgData name="Ray Kung" userId="f040dff3-2191-46ca-9bbc-8edbf56e8c11" providerId="ADAL" clId="{08F8FC5A-8788-044C-84F8-C21BC4796075}" dt="2022-07-08T03:45:11.646" v="683" actId="553"/>
          <ac:spMkLst>
            <pc:docMk/>
            <pc:sldMk cId="3571302438" sldId="271"/>
            <ac:spMk id="13" creationId="{1D36DD20-65C8-CDF7-540F-2F91E3406A86}"/>
          </ac:spMkLst>
        </pc:spChg>
        <pc:spChg chg="add mod">
          <ac:chgData name="Ray Kung" userId="f040dff3-2191-46ca-9bbc-8edbf56e8c11" providerId="ADAL" clId="{08F8FC5A-8788-044C-84F8-C21BC4796075}" dt="2022-07-08T03:45:20.328" v="684" actId="553"/>
          <ac:spMkLst>
            <pc:docMk/>
            <pc:sldMk cId="3571302438" sldId="271"/>
            <ac:spMk id="14" creationId="{14E63C2C-31C1-A21D-B1A3-4AB3136B406B}"/>
          </ac:spMkLst>
        </pc:spChg>
        <pc:picChg chg="add mod">
          <ac:chgData name="Ray Kung" userId="f040dff3-2191-46ca-9bbc-8edbf56e8c11" providerId="ADAL" clId="{08F8FC5A-8788-044C-84F8-C21BC4796075}" dt="2022-07-08T02:23:51.690" v="40" actId="1037"/>
          <ac:picMkLst>
            <pc:docMk/>
            <pc:sldMk cId="3571302438" sldId="271"/>
            <ac:picMk id="4" creationId="{F13AB23C-247C-D434-DF3A-9ADC7D0E885C}"/>
          </ac:picMkLst>
        </pc:picChg>
        <pc:picChg chg="add mod">
          <ac:chgData name="Ray Kung" userId="f040dff3-2191-46ca-9bbc-8edbf56e8c11" providerId="ADAL" clId="{08F8FC5A-8788-044C-84F8-C21BC4796075}" dt="2022-07-08T02:23:51.690" v="40" actId="1037"/>
          <ac:picMkLst>
            <pc:docMk/>
            <pc:sldMk cId="3571302438" sldId="271"/>
            <ac:picMk id="5" creationId="{3C45E1EE-B793-040B-8376-0091F9FCC9D8}"/>
          </ac:picMkLst>
        </pc:picChg>
        <pc:picChg chg="add mod">
          <ac:chgData name="Ray Kung" userId="f040dff3-2191-46ca-9bbc-8edbf56e8c11" providerId="ADAL" clId="{08F8FC5A-8788-044C-84F8-C21BC4796075}" dt="2022-07-08T02:23:51.690" v="40" actId="1037"/>
          <ac:picMkLst>
            <pc:docMk/>
            <pc:sldMk cId="3571302438" sldId="271"/>
            <ac:picMk id="6" creationId="{EE6E1B28-5FF3-E9BC-95B6-74E2B8AD6233}"/>
          </ac:picMkLst>
        </pc:picChg>
        <pc:picChg chg="add mod">
          <ac:chgData name="Ray Kung" userId="f040dff3-2191-46ca-9bbc-8edbf56e8c11" providerId="ADAL" clId="{08F8FC5A-8788-044C-84F8-C21BC4796075}" dt="2022-07-08T02:23:57.322" v="51" actId="1035"/>
          <ac:picMkLst>
            <pc:docMk/>
            <pc:sldMk cId="3571302438" sldId="271"/>
            <ac:picMk id="7" creationId="{CF2F5C22-AD53-ABBF-7169-1E455CA590B3}"/>
          </ac:picMkLst>
        </pc:picChg>
        <pc:picChg chg="add mod">
          <ac:chgData name="Ray Kung" userId="f040dff3-2191-46ca-9bbc-8edbf56e8c11" providerId="ADAL" clId="{08F8FC5A-8788-044C-84F8-C21BC4796075}" dt="2022-07-08T02:23:57.322" v="51" actId="1035"/>
          <ac:picMkLst>
            <pc:docMk/>
            <pc:sldMk cId="3571302438" sldId="271"/>
            <ac:picMk id="8" creationId="{8AEEEBBA-4B7E-4EEF-939E-3CEF25BB8EC7}"/>
          </ac:picMkLst>
        </pc:picChg>
      </pc:sldChg>
      <pc:sldChg chg="addSp delSp modSp new mod ord">
        <pc:chgData name="Ray Kung" userId="f040dff3-2191-46ca-9bbc-8edbf56e8c11" providerId="ADAL" clId="{08F8FC5A-8788-044C-84F8-C21BC4796075}" dt="2022-07-08T02:42:08.313" v="94" actId="113"/>
        <pc:sldMkLst>
          <pc:docMk/>
          <pc:sldMk cId="3092437848" sldId="272"/>
        </pc:sldMkLst>
        <pc:spChg chg="del">
          <ac:chgData name="Ray Kung" userId="f040dff3-2191-46ca-9bbc-8edbf56e8c11" providerId="ADAL" clId="{08F8FC5A-8788-044C-84F8-C21BC4796075}" dt="2022-07-08T02:22:16.709" v="9" actId="478"/>
          <ac:spMkLst>
            <pc:docMk/>
            <pc:sldMk cId="3092437848" sldId="272"/>
            <ac:spMk id="2" creationId="{DB6E7902-1174-1D1D-06E5-669F12649B61}"/>
          </ac:spMkLst>
        </pc:spChg>
        <pc:spChg chg="del">
          <ac:chgData name="Ray Kung" userId="f040dff3-2191-46ca-9bbc-8edbf56e8c11" providerId="ADAL" clId="{08F8FC5A-8788-044C-84F8-C21BC4796075}" dt="2022-07-08T02:22:17.768" v="10" actId="478"/>
          <ac:spMkLst>
            <pc:docMk/>
            <pc:sldMk cId="3092437848" sldId="272"/>
            <ac:spMk id="3" creationId="{79E62617-04BD-AA05-7EDA-4F4740F83435}"/>
          </ac:spMkLst>
        </pc:spChg>
        <pc:spChg chg="add mod">
          <ac:chgData name="Ray Kung" userId="f040dff3-2191-46ca-9bbc-8edbf56e8c11" providerId="ADAL" clId="{08F8FC5A-8788-044C-84F8-C21BC4796075}" dt="2022-07-08T02:42:08.313" v="94" actId="113"/>
          <ac:spMkLst>
            <pc:docMk/>
            <pc:sldMk cId="3092437848" sldId="272"/>
            <ac:spMk id="6" creationId="{C2F5F9E3-8F08-A4DA-B19E-7572E51F0E6A}"/>
          </ac:spMkLst>
        </pc:spChg>
        <pc:picChg chg="add mod">
          <ac:chgData name="Ray Kung" userId="f040dff3-2191-46ca-9bbc-8edbf56e8c11" providerId="ADAL" clId="{08F8FC5A-8788-044C-84F8-C21BC4796075}" dt="2022-07-08T02:40:06.091" v="63" actId="1076"/>
          <ac:picMkLst>
            <pc:docMk/>
            <pc:sldMk cId="3092437848" sldId="272"/>
            <ac:picMk id="5" creationId="{A663922D-4483-5285-CCB3-77DB7C993F78}"/>
          </ac:picMkLst>
        </pc:picChg>
      </pc:sldChg>
      <pc:sldChg chg="addSp delSp modSp new mod">
        <pc:chgData name="Ray Kung" userId="f040dff3-2191-46ca-9bbc-8edbf56e8c11" providerId="ADAL" clId="{08F8FC5A-8788-044C-84F8-C21BC4796075}" dt="2022-07-09T01:09:02.496" v="736" actId="1036"/>
        <pc:sldMkLst>
          <pc:docMk/>
          <pc:sldMk cId="1934321059" sldId="273"/>
        </pc:sldMkLst>
        <pc:spChg chg="del">
          <ac:chgData name="Ray Kung" userId="f040dff3-2191-46ca-9bbc-8edbf56e8c11" providerId="ADAL" clId="{08F8FC5A-8788-044C-84F8-C21BC4796075}" dt="2022-07-08T02:37:41.389" v="55" actId="478"/>
          <ac:spMkLst>
            <pc:docMk/>
            <pc:sldMk cId="1934321059" sldId="273"/>
            <ac:spMk id="2" creationId="{D3D6FD1D-F29B-1D2F-FCF4-54172C4C1A46}"/>
          </ac:spMkLst>
        </pc:spChg>
        <pc:spChg chg="del">
          <ac:chgData name="Ray Kung" userId="f040dff3-2191-46ca-9bbc-8edbf56e8c11" providerId="ADAL" clId="{08F8FC5A-8788-044C-84F8-C21BC4796075}" dt="2022-07-08T02:37:40.492" v="54" actId="478"/>
          <ac:spMkLst>
            <pc:docMk/>
            <pc:sldMk cId="1934321059" sldId="273"/>
            <ac:spMk id="3" creationId="{74330870-ABBC-CBFE-8C24-8C083D85A5E8}"/>
          </ac:spMkLst>
        </pc:spChg>
        <pc:spChg chg="add mod">
          <ac:chgData name="Ray Kung" userId="f040dff3-2191-46ca-9bbc-8edbf56e8c11" providerId="ADAL" clId="{08F8FC5A-8788-044C-84F8-C21BC4796075}" dt="2022-07-09T01:08:55.887" v="734" actId="20577"/>
          <ac:spMkLst>
            <pc:docMk/>
            <pc:sldMk cId="1934321059" sldId="273"/>
            <ac:spMk id="6" creationId="{8DF872AB-BCB1-0C3D-D0C4-7C4969E493D5}"/>
          </ac:spMkLst>
        </pc:spChg>
        <pc:spChg chg="add mod">
          <ac:chgData name="Ray Kung" userId="f040dff3-2191-46ca-9bbc-8edbf56e8c11" providerId="ADAL" clId="{08F8FC5A-8788-044C-84F8-C21BC4796075}" dt="2022-07-09T01:08:27.985" v="708" actId="1076"/>
          <ac:spMkLst>
            <pc:docMk/>
            <pc:sldMk cId="1934321059" sldId="273"/>
            <ac:spMk id="8" creationId="{3F15055A-C4BC-6912-0D77-50CC5A725170}"/>
          </ac:spMkLst>
        </pc:spChg>
        <pc:spChg chg="add mod">
          <ac:chgData name="Ray Kung" userId="f040dff3-2191-46ca-9bbc-8edbf56e8c11" providerId="ADAL" clId="{08F8FC5A-8788-044C-84F8-C21BC4796075}" dt="2022-07-09T01:08:35.061" v="709" actId="1076"/>
          <ac:spMkLst>
            <pc:docMk/>
            <pc:sldMk cId="1934321059" sldId="273"/>
            <ac:spMk id="9" creationId="{DE6D604F-2C51-7E24-A1A8-25384BF6B0D6}"/>
          </ac:spMkLst>
        </pc:spChg>
        <pc:spChg chg="add mod">
          <ac:chgData name="Ray Kung" userId="f040dff3-2191-46ca-9bbc-8edbf56e8c11" providerId="ADAL" clId="{08F8FC5A-8788-044C-84F8-C21BC4796075}" dt="2022-07-09T01:08:43.506" v="712" actId="1076"/>
          <ac:spMkLst>
            <pc:docMk/>
            <pc:sldMk cId="1934321059" sldId="273"/>
            <ac:spMk id="10" creationId="{C32DA8A2-3C8C-1C34-9DAB-26F65B10F0D6}"/>
          </ac:spMkLst>
        </pc:spChg>
        <pc:picChg chg="add mod">
          <ac:chgData name="Ray Kung" userId="f040dff3-2191-46ca-9bbc-8edbf56e8c11" providerId="ADAL" clId="{08F8FC5A-8788-044C-84F8-C21BC4796075}" dt="2022-07-09T01:09:02.496" v="736" actId="1036"/>
          <ac:picMkLst>
            <pc:docMk/>
            <pc:sldMk cId="1934321059" sldId="273"/>
            <ac:picMk id="4" creationId="{AA125649-9A42-6DED-2483-40D7DA08E799}"/>
          </ac:picMkLst>
        </pc:picChg>
        <pc:picChg chg="add mod">
          <ac:chgData name="Ray Kung" userId="f040dff3-2191-46ca-9bbc-8edbf56e8c11" providerId="ADAL" clId="{08F8FC5A-8788-044C-84F8-C21BC4796075}" dt="2022-07-09T01:08:37.556" v="711" actId="1076"/>
          <ac:picMkLst>
            <pc:docMk/>
            <pc:sldMk cId="1934321059" sldId="273"/>
            <ac:picMk id="5" creationId="{3CA4CE1D-0933-72EA-4348-FDCFE21BDF79}"/>
          </ac:picMkLst>
        </pc:picChg>
        <pc:picChg chg="add mod">
          <ac:chgData name="Ray Kung" userId="f040dff3-2191-46ca-9bbc-8edbf56e8c11" providerId="ADAL" clId="{08F8FC5A-8788-044C-84F8-C21BC4796075}" dt="2022-07-09T01:08:07.044" v="706" actId="14100"/>
          <ac:picMkLst>
            <pc:docMk/>
            <pc:sldMk cId="1934321059" sldId="273"/>
            <ac:picMk id="7" creationId="{56F6BEDD-F79C-5FD6-D644-2CFAF969A202}"/>
          </ac:picMkLst>
        </pc:picChg>
      </pc:sldChg>
    </pc:docChg>
  </pc:docChgLst>
  <pc:docChgLst>
    <pc:chgData name="Ray Kung" userId="S::ykung6@jh.edu::f040dff3-2191-46ca-9bbc-8edbf56e8c11" providerId="AD" clId="Web-{3B498B3E-C296-4D0D-92B0-1ABA3B04A5CE}"/>
    <pc:docChg chg="modSld sldOrd">
      <pc:chgData name="Ray Kung" userId="S::ykung6@jh.edu::f040dff3-2191-46ca-9bbc-8edbf56e8c11" providerId="AD" clId="Web-{3B498B3E-C296-4D0D-92B0-1ABA3B04A5CE}" dt="2022-07-31T20:06:41.577" v="8" actId="20577"/>
      <pc:docMkLst>
        <pc:docMk/>
      </pc:docMkLst>
      <pc:sldChg chg="modSp ord">
        <pc:chgData name="Ray Kung" userId="S::ykung6@jh.edu::f040dff3-2191-46ca-9bbc-8edbf56e8c11" providerId="AD" clId="Web-{3B498B3E-C296-4D0D-92B0-1ABA3B04A5CE}" dt="2022-07-31T20:04:39.636" v="2"/>
        <pc:sldMkLst>
          <pc:docMk/>
          <pc:sldMk cId="1684915752" sldId="270"/>
        </pc:sldMkLst>
        <pc:spChg chg="mod">
          <ac:chgData name="Ray Kung" userId="S::ykung6@jh.edu::f040dff3-2191-46ca-9bbc-8edbf56e8c11" providerId="AD" clId="Web-{3B498B3E-C296-4D0D-92B0-1ABA3B04A5CE}" dt="2022-07-31T20:04:37.557" v="1" actId="20577"/>
          <ac:spMkLst>
            <pc:docMk/>
            <pc:sldMk cId="1684915752" sldId="270"/>
            <ac:spMk id="2" creationId="{94124976-286D-F343-8F28-68B54D387CC9}"/>
          </ac:spMkLst>
        </pc:spChg>
      </pc:sldChg>
      <pc:sldChg chg="modSp">
        <pc:chgData name="Ray Kung" userId="S::ykung6@jh.edu::f040dff3-2191-46ca-9bbc-8edbf56e8c11" providerId="AD" clId="Web-{3B498B3E-C296-4D0D-92B0-1ABA3B04A5CE}" dt="2022-07-31T20:05:45.794" v="4" actId="20577"/>
        <pc:sldMkLst>
          <pc:docMk/>
          <pc:sldMk cId="3092437848" sldId="272"/>
        </pc:sldMkLst>
        <pc:spChg chg="mod">
          <ac:chgData name="Ray Kung" userId="S::ykung6@jh.edu::f040dff3-2191-46ca-9bbc-8edbf56e8c11" providerId="AD" clId="Web-{3B498B3E-C296-4D0D-92B0-1ABA3B04A5CE}" dt="2022-07-31T20:05:45.794" v="4" actId="20577"/>
          <ac:spMkLst>
            <pc:docMk/>
            <pc:sldMk cId="3092437848" sldId="272"/>
            <ac:spMk id="6" creationId="{C2F5F9E3-8F08-A4DA-B19E-7572E51F0E6A}"/>
          </ac:spMkLst>
        </pc:spChg>
      </pc:sldChg>
      <pc:sldChg chg="modSp ord">
        <pc:chgData name="Ray Kung" userId="S::ykung6@jh.edu::f040dff3-2191-46ca-9bbc-8edbf56e8c11" providerId="AD" clId="Web-{3B498B3E-C296-4D0D-92B0-1ABA3B04A5CE}" dt="2022-07-31T20:06:41.577" v="8" actId="20577"/>
        <pc:sldMkLst>
          <pc:docMk/>
          <pc:sldMk cId="1934321059" sldId="273"/>
        </pc:sldMkLst>
        <pc:spChg chg="mod">
          <ac:chgData name="Ray Kung" userId="S::ykung6@jh.edu::f040dff3-2191-46ca-9bbc-8edbf56e8c11" providerId="AD" clId="Web-{3B498B3E-C296-4D0D-92B0-1ABA3B04A5CE}" dt="2022-07-31T20:06:41.577" v="8" actId="20577"/>
          <ac:spMkLst>
            <pc:docMk/>
            <pc:sldMk cId="1934321059" sldId="273"/>
            <ac:spMk id="6" creationId="{8DF872AB-BCB1-0C3D-D0C4-7C4969E493D5}"/>
          </ac:spMkLst>
        </pc:spChg>
      </pc:sldChg>
    </pc:docChg>
  </pc:docChgLst>
</pc:chgInfo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C2C136C-B8A3-6F44-A17B-7A3EFBF66F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971550" y="1646133"/>
            <a:ext cx="5829300" cy="3501813"/>
          </a:xfrm>
        </p:spPr>
        <p:txBody>
          <a:bodyPr anchor="b"/>
          <a:lstStyle>
            <a:lvl1pPr algn="ctr">
              <a:defRPr sz="8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75F4D11C-6E9F-F446-A6CA-9F3617DFFE1C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3520"/>
            </a:lvl1pPr>
            <a:lvl2pPr marL="670575" indent="0" algn="ctr">
              <a:buNone/>
              <a:defRPr sz="2933"/>
            </a:lvl2pPr>
            <a:lvl3pPr marL="1341150" indent="0" algn="ctr">
              <a:buNone/>
              <a:defRPr sz="2640"/>
            </a:lvl3pPr>
            <a:lvl4pPr marL="2011726" indent="0" algn="ctr">
              <a:buNone/>
              <a:defRPr sz="2347"/>
            </a:lvl4pPr>
            <a:lvl5pPr marL="2682301" indent="0" algn="ctr">
              <a:buNone/>
              <a:defRPr sz="2347"/>
            </a:lvl5pPr>
            <a:lvl6pPr marL="3352876" indent="0" algn="ctr">
              <a:buNone/>
              <a:defRPr sz="2347"/>
            </a:lvl6pPr>
            <a:lvl7pPr marL="4023451" indent="0" algn="ctr">
              <a:buNone/>
              <a:defRPr sz="2347"/>
            </a:lvl7pPr>
            <a:lvl8pPr marL="4694027" indent="0" algn="ctr">
              <a:buNone/>
              <a:defRPr sz="2347"/>
            </a:lvl8pPr>
            <a:lvl9pPr marL="5364602" indent="0" algn="ctr">
              <a:buNone/>
              <a:defRPr sz="2347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EF6157E-C586-0143-BF97-6784E930C3F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8A802CA6-0EC6-3341-BC05-7B70FD1026E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272549BC-120B-A74A-8FE3-AB88974307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29569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D31A5D4-CED8-FF4F-9A2B-A236892D9FB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F0CAA81-46A1-F940-A1C3-8D90A650C10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7E7E747-9380-1E41-8166-89D2686989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DF7F4F4-1B89-E744-A305-D0E63BDE330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1E5FAE8-A840-2E43-838B-B8F5ACA9378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641977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95BFE890-89B2-9F48-8BF1-FA09CB1B0E0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756026-73E9-504F-BBA3-ACBF2319B91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B9E4462-892F-8F46-AAAF-1C38B15FE5A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FA74A0D-F1BC-7144-8576-37C898B2BA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2A3F354-1584-3142-A57E-60DFABB0E19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586068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7B5CDA-8C4F-3A40-B794-654193BBFAB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F84086-55B4-9C42-B6FA-D9A57640D35B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AF025BFF-7032-2843-BAD2-A3B4579CA95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3095E7-5AB4-444B-BFFD-5B68E6EF7E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E2CA53F-E037-D84C-8648-A1A45648DF1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217976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35CAB58-AA2F-1A4C-89FD-E034F018474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0304" y="2507617"/>
            <a:ext cx="6703695" cy="4184014"/>
          </a:xfrm>
        </p:spPr>
        <p:txBody>
          <a:bodyPr anchor="b"/>
          <a:lstStyle>
            <a:lvl1pPr>
              <a:defRPr sz="88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579C33F-9A4F-9949-8C20-2373C6045B1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0304" y="6731213"/>
            <a:ext cx="6703695" cy="2200274"/>
          </a:xfrm>
        </p:spPr>
        <p:txBody>
          <a:bodyPr/>
          <a:lstStyle>
            <a:lvl1pPr marL="0" indent="0">
              <a:buNone/>
              <a:defRPr sz="3520">
                <a:solidFill>
                  <a:schemeClr val="tx1">
                    <a:tint val="75000"/>
                  </a:schemeClr>
                </a:solidFill>
              </a:defRPr>
            </a:lvl1pPr>
            <a:lvl2pPr marL="670575" indent="0">
              <a:buNone/>
              <a:defRPr sz="2933">
                <a:solidFill>
                  <a:schemeClr val="tx1">
                    <a:tint val="75000"/>
                  </a:schemeClr>
                </a:solidFill>
              </a:defRPr>
            </a:lvl2pPr>
            <a:lvl3pPr marL="1341150" indent="0">
              <a:buNone/>
              <a:defRPr sz="2640">
                <a:solidFill>
                  <a:schemeClr val="tx1">
                    <a:tint val="75000"/>
                  </a:schemeClr>
                </a:solidFill>
              </a:defRPr>
            </a:lvl3pPr>
            <a:lvl4pPr marL="201172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4pPr>
            <a:lvl5pPr marL="268230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5pPr>
            <a:lvl6pPr marL="3352876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6pPr>
            <a:lvl7pPr marL="4023451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7pPr>
            <a:lvl8pPr marL="4694027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8pPr>
            <a:lvl9pPr marL="5364602" indent="0">
              <a:buNone/>
              <a:defRPr sz="2347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D2CE8FC-0202-2040-8613-45552F98A8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E85583E9-245C-D948-9E8F-91FB9905AF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D327D8B-BD59-DE44-8669-9F1D0C811F4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1041205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8B235BA-279A-0643-A8E4-B309CFFC67E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E6789CEB-B67F-FE43-97D1-2D22801C975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0C1C1B42-50A0-3A49-98F4-294FA0B86E4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F2E2165-C885-934B-AA37-2AD21C7AE61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5EA1EC-0CC9-DD4C-9E1D-BAA9D344D46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1726E22A-21A1-4947-B402-1CD0FAE52B3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270554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23E595B-A267-9440-AC95-E2F430DAC10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535517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0B5A18B-0698-6F49-92A1-DFBC3BDF8D56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5365" y="2465706"/>
            <a:ext cx="3288089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DF51CC5-12A8-CA48-A99C-DB877F54CAD6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35365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016ECD28-7D04-6C44-9929-4F80F78B537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3520" b="1"/>
            </a:lvl1pPr>
            <a:lvl2pPr marL="670575" indent="0">
              <a:buNone/>
              <a:defRPr sz="2933" b="1"/>
            </a:lvl2pPr>
            <a:lvl3pPr marL="1341150" indent="0">
              <a:buNone/>
              <a:defRPr sz="2640" b="1"/>
            </a:lvl3pPr>
            <a:lvl4pPr marL="2011726" indent="0">
              <a:buNone/>
              <a:defRPr sz="2347" b="1"/>
            </a:lvl4pPr>
            <a:lvl5pPr marL="2682301" indent="0">
              <a:buNone/>
              <a:defRPr sz="2347" b="1"/>
            </a:lvl5pPr>
            <a:lvl6pPr marL="3352876" indent="0">
              <a:buNone/>
              <a:defRPr sz="2347" b="1"/>
            </a:lvl6pPr>
            <a:lvl7pPr marL="4023451" indent="0">
              <a:buNone/>
              <a:defRPr sz="2347" b="1"/>
            </a:lvl7pPr>
            <a:lvl8pPr marL="4694027" indent="0">
              <a:buNone/>
              <a:defRPr sz="2347" b="1"/>
            </a:lvl8pPr>
            <a:lvl9pPr marL="5364602" indent="0">
              <a:buNone/>
              <a:defRPr sz="2347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9C26ECAF-20DD-FF40-A3A1-773EABA7A8C3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D3E7E19D-205A-E540-8661-F45D2016EA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572B5DEB-6D29-904E-BF16-1EF690C6BD5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2EDA611-B1D5-7746-9886-EEBE391858F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662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04DFC31-019E-8E4A-901E-264A559017F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84448BC6-37DE-1840-939D-A8218351E4D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7A7417D2-49FB-9843-9DFC-92366684C1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CFE5ED50-F7F5-A946-8858-0D3E7DF573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535775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DF7F51C-D407-0647-99D9-3995CF3E640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965A1364-4B5A-844B-9BFA-A15F1DFCECB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003ED20C-CA8E-A743-A6B1-3EC02B54DA9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7394561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6C52E80-9417-6644-92F4-ECCA654EF7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839BD6B-FA11-0642-831E-F40823363013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>
              <a:defRPr sz="4693"/>
            </a:lvl1pPr>
            <a:lvl2pPr>
              <a:defRPr sz="4107"/>
            </a:lvl2pPr>
            <a:lvl3pPr>
              <a:defRPr sz="3520"/>
            </a:lvl3pPr>
            <a:lvl4pPr>
              <a:defRPr sz="2933"/>
            </a:lvl4pPr>
            <a:lvl5pPr>
              <a:defRPr sz="2933"/>
            </a:lvl5pPr>
            <a:lvl6pPr>
              <a:defRPr sz="2933"/>
            </a:lvl6pPr>
            <a:lvl7pPr>
              <a:defRPr sz="2933"/>
            </a:lvl7pPr>
            <a:lvl8pPr>
              <a:defRPr sz="2933"/>
            </a:lvl8pPr>
            <a:lvl9pPr>
              <a:defRPr sz="293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855FE64-5EA6-474E-AD19-E7FA8525767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D121F55-26CA-CC41-A85E-A334455949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25577F55-2EFD-2746-B6EF-BFE123EDAE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59E56A94-734C-854B-8623-E3E49F507A3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0677370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3C528B2-DC58-FC4F-BC95-1E3880F74E1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4693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2D87D339-9F35-1A4E-85E7-01AA65EBCD6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3304282" y="1448224"/>
            <a:ext cx="3934778" cy="7147983"/>
          </a:xfrm>
        </p:spPr>
        <p:txBody>
          <a:bodyPr/>
          <a:lstStyle>
            <a:lvl1pPr marL="0" indent="0">
              <a:buNone/>
              <a:defRPr sz="4693"/>
            </a:lvl1pPr>
            <a:lvl2pPr marL="670575" indent="0">
              <a:buNone/>
              <a:defRPr sz="4107"/>
            </a:lvl2pPr>
            <a:lvl3pPr marL="1341150" indent="0">
              <a:buNone/>
              <a:defRPr sz="3520"/>
            </a:lvl3pPr>
            <a:lvl4pPr marL="2011726" indent="0">
              <a:buNone/>
              <a:defRPr sz="2933"/>
            </a:lvl4pPr>
            <a:lvl5pPr marL="2682301" indent="0">
              <a:buNone/>
              <a:defRPr sz="2933"/>
            </a:lvl5pPr>
            <a:lvl6pPr marL="3352876" indent="0">
              <a:buNone/>
              <a:defRPr sz="2933"/>
            </a:lvl6pPr>
            <a:lvl7pPr marL="4023451" indent="0">
              <a:buNone/>
              <a:defRPr sz="2933"/>
            </a:lvl7pPr>
            <a:lvl8pPr marL="4694027" indent="0">
              <a:buNone/>
              <a:defRPr sz="2933"/>
            </a:lvl8pPr>
            <a:lvl9pPr marL="5364602" indent="0">
              <a:buNone/>
              <a:defRPr sz="2933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08D15C9B-7BF8-C34E-AA5E-0D99E01B91E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2347"/>
            </a:lvl1pPr>
            <a:lvl2pPr marL="670575" indent="0">
              <a:buNone/>
              <a:defRPr sz="2053"/>
            </a:lvl2pPr>
            <a:lvl3pPr marL="1341150" indent="0">
              <a:buNone/>
              <a:defRPr sz="1760"/>
            </a:lvl3pPr>
            <a:lvl4pPr marL="2011726" indent="0">
              <a:buNone/>
              <a:defRPr sz="1467"/>
            </a:lvl4pPr>
            <a:lvl5pPr marL="2682301" indent="0">
              <a:buNone/>
              <a:defRPr sz="1467"/>
            </a:lvl5pPr>
            <a:lvl6pPr marL="3352876" indent="0">
              <a:buNone/>
              <a:defRPr sz="1467"/>
            </a:lvl6pPr>
            <a:lvl7pPr marL="4023451" indent="0">
              <a:buNone/>
              <a:defRPr sz="1467"/>
            </a:lvl7pPr>
            <a:lvl8pPr marL="4694027" indent="0">
              <a:buNone/>
              <a:defRPr sz="1467"/>
            </a:lvl8pPr>
            <a:lvl9pPr marL="5364602" indent="0">
              <a:buNone/>
              <a:defRPr sz="146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D46DFAB4-9EFE-AA4B-B633-D53C9C8C10C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81CE48C1-5A2B-E54D-B25C-DFD00AB96DB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0BC29BE-E26B-AF4E-93F2-745DCF26F24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9051307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FE7F4E6D-DEAB-CE4E-93E4-F628CD49BD7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534353" y="535517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3BDE84D1-B7B9-3F43-883B-2F7264FEC9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E85EF8A-BDBA-B241-8F8F-2747353E5970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534353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23FD611-51A5-D040-B277-BC7E1B81FE5A}" type="datetimeFigureOut">
              <a:rPr lang="en-US" smtClean="0"/>
              <a:t>8/6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D857014-579D-6244-91DB-A7C1996E19C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2574608" y="9322647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45BC2BDA-05CC-6043-9238-5EDDFA8B21A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5489258" y="9322647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7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5AE5828-0817-CA4A-AB3C-2DB0D18DD0F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87522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1341150" rtl="0" eaLnBrk="1" latinLnBrk="0" hangingPunct="1">
        <a:lnSpc>
          <a:spcPct val="90000"/>
        </a:lnSpc>
        <a:spcBef>
          <a:spcPct val="0"/>
        </a:spcBef>
        <a:buNone/>
        <a:defRPr sz="6453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35288" indent="-335288" algn="l" defTabSz="1341150" rtl="0" eaLnBrk="1" latinLnBrk="0" hangingPunct="1">
        <a:lnSpc>
          <a:spcPct val="90000"/>
        </a:lnSpc>
        <a:spcBef>
          <a:spcPts val="1467"/>
        </a:spcBef>
        <a:buFont typeface="Arial" panose="020B0604020202020204" pitchFamily="34" charset="0"/>
        <a:buChar char="•"/>
        <a:defRPr sz="4107" kern="1200">
          <a:solidFill>
            <a:schemeClr val="tx1"/>
          </a:solidFill>
          <a:latin typeface="+mn-lt"/>
          <a:ea typeface="+mn-ea"/>
          <a:cs typeface="+mn-cs"/>
        </a:defRPr>
      </a:lvl1pPr>
      <a:lvl2pPr marL="100586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3520" kern="1200">
          <a:solidFill>
            <a:schemeClr val="tx1"/>
          </a:solidFill>
          <a:latin typeface="+mn-lt"/>
          <a:ea typeface="+mn-ea"/>
          <a:cs typeface="+mn-cs"/>
        </a:defRPr>
      </a:lvl2pPr>
      <a:lvl3pPr marL="1676438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933" kern="1200">
          <a:solidFill>
            <a:schemeClr val="tx1"/>
          </a:solidFill>
          <a:latin typeface="+mn-lt"/>
          <a:ea typeface="+mn-ea"/>
          <a:cs typeface="+mn-cs"/>
        </a:defRPr>
      </a:lvl3pPr>
      <a:lvl4pPr marL="2347013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301758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68816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358739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5029314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699890" indent="-335288" algn="l" defTabSz="1341150" rtl="0" eaLnBrk="1" latinLnBrk="0" hangingPunct="1">
        <a:lnSpc>
          <a:spcPct val="90000"/>
        </a:lnSpc>
        <a:spcBef>
          <a:spcPts val="733"/>
        </a:spcBef>
        <a:buFont typeface="Arial" panose="020B0604020202020204" pitchFamily="34" charset="0"/>
        <a:buChar char="•"/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1pPr>
      <a:lvl2pPr marL="670575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2pPr>
      <a:lvl3pPr marL="1341150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3pPr>
      <a:lvl4pPr marL="201172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4pPr>
      <a:lvl5pPr marL="268230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5pPr>
      <a:lvl6pPr marL="3352876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6pPr>
      <a:lvl7pPr marL="4023451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7pPr>
      <a:lvl8pPr marL="4694027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8pPr>
      <a:lvl9pPr marL="5364602" algn="l" defTabSz="1341150" rtl="0" eaLnBrk="1" latinLnBrk="0" hangingPunct="1">
        <a:defRPr sz="26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emf"/><Relationship Id="rId4" Type="http://schemas.openxmlformats.org/officeDocument/2006/relationships/image" Target="../media/image3.em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7.emf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11.emf"/><Relationship Id="rId2" Type="http://schemas.openxmlformats.org/officeDocument/2006/relationships/image" Target="../media/image10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14.emf"/><Relationship Id="rId5" Type="http://schemas.openxmlformats.org/officeDocument/2006/relationships/image" Target="../media/image13.emf"/><Relationship Id="rId4" Type="http://schemas.openxmlformats.org/officeDocument/2006/relationships/image" Target="../media/image12.emf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8" name="Group 7">
            <a:extLst>
              <a:ext uri="{FF2B5EF4-FFF2-40B4-BE49-F238E27FC236}">
                <a16:creationId xmlns:a16="http://schemas.microsoft.com/office/drawing/2014/main" id="{A6A171FB-EE64-8745-83E2-73A205B4D699}"/>
              </a:ext>
            </a:extLst>
          </p:cNvPr>
          <p:cNvGrpSpPr/>
          <p:nvPr/>
        </p:nvGrpSpPr>
        <p:grpSpPr>
          <a:xfrm>
            <a:off x="1135184" y="606669"/>
            <a:ext cx="5502031" cy="4851453"/>
            <a:chOff x="127000" y="1222131"/>
            <a:chExt cx="7518400" cy="6629400"/>
          </a:xfrm>
        </p:grpSpPr>
        <p:pic>
          <p:nvPicPr>
            <p:cNvPr id="4" name="Picture 3">
              <a:extLst>
                <a:ext uri="{FF2B5EF4-FFF2-40B4-BE49-F238E27FC236}">
                  <a16:creationId xmlns:a16="http://schemas.microsoft.com/office/drawing/2014/main" id="{DA7E467D-FAEA-624D-9C47-2AB9ACC29BBB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127000" y="1222131"/>
              <a:ext cx="3759200" cy="3314700"/>
            </a:xfrm>
            <a:prstGeom prst="rect">
              <a:avLst/>
            </a:prstGeom>
          </p:spPr>
        </p:pic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52FD0D9E-3CF5-8B49-BF55-256AA307F745}"/>
                </a:ext>
              </a:extLst>
            </p:cNvPr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3886200" y="1222131"/>
              <a:ext cx="3759200" cy="3314700"/>
            </a:xfrm>
            <a:prstGeom prst="rect">
              <a:avLst/>
            </a:prstGeom>
          </p:spPr>
        </p:pic>
        <p:pic>
          <p:nvPicPr>
            <p:cNvPr id="6" name="Picture 5">
              <a:extLst>
                <a:ext uri="{FF2B5EF4-FFF2-40B4-BE49-F238E27FC236}">
                  <a16:creationId xmlns:a16="http://schemas.microsoft.com/office/drawing/2014/main" id="{B110F379-45C3-9C4B-ACCD-0884586D2FFE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127000" y="4536831"/>
              <a:ext cx="3759200" cy="3314700"/>
            </a:xfrm>
            <a:prstGeom prst="rect">
              <a:avLst/>
            </a:prstGeom>
          </p:spPr>
        </p:pic>
        <p:pic>
          <p:nvPicPr>
            <p:cNvPr id="7" name="Picture 6">
              <a:extLst>
                <a:ext uri="{FF2B5EF4-FFF2-40B4-BE49-F238E27FC236}">
                  <a16:creationId xmlns:a16="http://schemas.microsoft.com/office/drawing/2014/main" id="{9694F6A8-CC1E-D844-A63C-2BB81B967220}"/>
                </a:ext>
              </a:extLst>
            </p:cNvPr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3886200" y="4536831"/>
              <a:ext cx="3759200" cy="3314700"/>
            </a:xfrm>
            <a:prstGeom prst="rect">
              <a:avLst/>
            </a:prstGeom>
          </p:spPr>
        </p:pic>
      </p:grpSp>
      <p:sp>
        <p:nvSpPr>
          <p:cNvPr id="2" name="TextBox 1">
            <a:extLst>
              <a:ext uri="{FF2B5EF4-FFF2-40B4-BE49-F238E27FC236}">
                <a16:creationId xmlns:a16="http://schemas.microsoft.com/office/drawing/2014/main" id="{94124976-286D-F343-8F28-68B54D387CC9}"/>
              </a:ext>
            </a:extLst>
          </p:cNvPr>
          <p:cNvSpPr txBox="1"/>
          <p:nvPr/>
        </p:nvSpPr>
        <p:spPr>
          <a:xfrm>
            <a:off x="1135184" y="5677786"/>
            <a:ext cx="5943600" cy="116955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ure S1. Spider plots for the indicated treatment groups. </a:t>
            </a:r>
            <a:r>
              <a:rPr lang="en-US" sz="1400" dirty="0">
                <a:latin typeface="Times New Roman"/>
                <a:cs typeface="Times New Roman"/>
              </a:rPr>
              <a:t>BALB/c mice were inoculated with 5e5 CT26 tumor cells subcutaneously. 10 days later, following establishment of tumors, mice were administered 50ug of Alb-IL2. 1 day later, mice were treated with 5e6 Salmonella intravenously. Mice were treated again with 50ug of Alb-IL2 on day 17. 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6849157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AA125649-9A42-6DED-2483-40D7DA08E799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09575" y="3124200"/>
            <a:ext cx="4611007" cy="2336800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CA4CE1D-0933-72EA-4348-FDCFE21BDF79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36550" y="609600"/>
            <a:ext cx="4684032" cy="233680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8DF872AB-BCB1-0C3D-D0C4-7C4969E493D5}"/>
              </a:ext>
            </a:extLst>
          </p:cNvPr>
          <p:cNvSpPr txBox="1"/>
          <p:nvPr/>
        </p:nvSpPr>
        <p:spPr>
          <a:xfrm>
            <a:off x="551643" y="8592208"/>
            <a:ext cx="6669113" cy="116955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ure S2. Growth, survival, and body weight curve of TC-1 tumor-bearing mice treated with Salmonella + Alb-IL2. </a:t>
            </a:r>
            <a:r>
              <a:rPr lang="en-US" sz="1400" dirty="0">
                <a:latin typeface="Times New Roman"/>
                <a:cs typeface="Times New Roman"/>
              </a:rPr>
              <a:t>C57BL/6 mice were inoculated with 5e5 TC-1 tumor cells subcutaneously. 10 days later, following establishment of tumors, mice were administered 50ug of Alb-IL2. 1 day later, mice were treated with 5e6 </a:t>
            </a:r>
            <a:r>
              <a:rPr lang="en-US" sz="1400" i="1" dirty="0">
                <a:latin typeface="Times New Roman"/>
                <a:cs typeface="Times New Roman"/>
              </a:rPr>
              <a:t>Salmonella</a:t>
            </a:r>
            <a:r>
              <a:rPr lang="en-US" sz="1400" dirty="0">
                <a:latin typeface="Times New Roman"/>
                <a:cs typeface="Times New Roman"/>
              </a:rPr>
              <a:t> intravenously. Mice were treated again with 50ug of Alb-IL2 on day 17.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7" name="Picture 6">
            <a:extLst>
              <a:ext uri="{FF2B5EF4-FFF2-40B4-BE49-F238E27FC236}">
                <a16:creationId xmlns:a16="http://schemas.microsoft.com/office/drawing/2014/main" id="{56F6BEDD-F79C-5FD6-D644-2CFAF969A202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551642" y="5588000"/>
            <a:ext cx="4454527" cy="2336800"/>
          </a:xfrm>
          <a:prstGeom prst="rect">
            <a:avLst/>
          </a:prstGeom>
        </p:spPr>
      </p:pic>
      <p:sp>
        <p:nvSpPr>
          <p:cNvPr id="8" name="TextBox 7">
            <a:extLst>
              <a:ext uri="{FF2B5EF4-FFF2-40B4-BE49-F238E27FC236}">
                <a16:creationId xmlns:a16="http://schemas.microsoft.com/office/drawing/2014/main" id="{3F15055A-C4BC-6912-0D77-50CC5A725170}"/>
              </a:ext>
            </a:extLst>
          </p:cNvPr>
          <p:cNvSpPr txBox="1"/>
          <p:nvPr/>
        </p:nvSpPr>
        <p:spPr>
          <a:xfrm>
            <a:off x="265946" y="45720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>
                <a:latin typeface="Helvetica" pitchFamily="2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DE6D604F-2C51-7E24-A1A8-25384BF6B0D6}"/>
              </a:ext>
            </a:extLst>
          </p:cNvPr>
          <p:cNvSpPr txBox="1"/>
          <p:nvPr/>
        </p:nvSpPr>
        <p:spPr>
          <a:xfrm>
            <a:off x="336550" y="3098800"/>
            <a:ext cx="287258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>
                <a:latin typeface="Helvetica" pitchFamily="2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C32DA8A2-3C8C-1C34-9DAB-26F65B10F0D6}"/>
              </a:ext>
            </a:extLst>
          </p:cNvPr>
          <p:cNvSpPr txBox="1"/>
          <p:nvPr/>
        </p:nvSpPr>
        <p:spPr>
          <a:xfrm>
            <a:off x="336550" y="5834024"/>
            <a:ext cx="290464" cy="26898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100" b="1">
                <a:latin typeface="Helvetica" pitchFamily="2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93432105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 descr="Chart&#10;&#10;Description automatically generated">
            <a:extLst>
              <a:ext uri="{FF2B5EF4-FFF2-40B4-BE49-F238E27FC236}">
                <a16:creationId xmlns:a16="http://schemas.microsoft.com/office/drawing/2014/main" id="{A663922D-4483-5285-CCB3-77DB7C993F7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42950" y="1250950"/>
            <a:ext cx="4666396" cy="3536950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C2F5F9E3-8F08-A4DA-B19E-7572E51F0E6A}"/>
              </a:ext>
            </a:extLst>
          </p:cNvPr>
          <p:cNvSpPr txBox="1"/>
          <p:nvPr/>
        </p:nvSpPr>
        <p:spPr>
          <a:xfrm>
            <a:off x="1058984" y="5270501"/>
            <a:ext cx="5943600" cy="1384995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ure S3. Bioactivity of Alb-IL2. </a:t>
            </a:r>
            <a:r>
              <a:rPr lang="en-US" sz="1400" dirty="0">
                <a:latin typeface="Times New Roman"/>
                <a:cs typeface="Times New Roman"/>
              </a:rPr>
              <a:t>Memory CD8+ T Cells generated in house were rested, then stimulated with our Alb-IL2 alongside relevant controls as indicated in the figure. 20 minutes later, the cells were fixed in methanol, collected, and analyzed for pSTAT5 levels by </a:t>
            </a:r>
            <a:r>
              <a:rPr lang="en-US" sz="1400" dirty="0" err="1">
                <a:latin typeface="Times New Roman"/>
                <a:cs typeface="Times New Roman"/>
              </a:rPr>
              <a:t>phosphoflow</a:t>
            </a:r>
            <a:r>
              <a:rPr lang="en-US" sz="1400" dirty="0">
                <a:latin typeface="Times New Roman"/>
                <a:cs typeface="Times New Roman"/>
              </a:rPr>
              <a:t>. Stimulation condition is indicated on the right. Level normalized to mode is shown on the Y axis.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09243784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EF84EE70-5CE3-5044-88B1-F5054B3343B1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9469" y="2642207"/>
            <a:ext cx="7473462" cy="3873108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FDAB2AA7-08B1-DF4B-91E2-D6C7E3242D76}"/>
              </a:ext>
            </a:extLst>
          </p:cNvPr>
          <p:cNvSpPr txBox="1"/>
          <p:nvPr/>
        </p:nvSpPr>
        <p:spPr>
          <a:xfrm>
            <a:off x="551643" y="6611008"/>
            <a:ext cx="6669113" cy="116955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Figure S4. Flow gating strategy for identification of T cell populations and pro-inflammatory cytokine production. </a:t>
            </a:r>
            <a:r>
              <a:rPr lang="en-US" sz="1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Lymphocytes from the tumor and draining lymph nodes were isolated two weeks after the initiation of treatment and analyzed using flow cytometry. This gating strategy allowed for the identification of T cell populations and observation of their effector functions.</a:t>
            </a:r>
          </a:p>
        </p:txBody>
      </p:sp>
    </p:spTree>
    <p:extLst>
      <p:ext uri="{BB962C8B-B14F-4D97-AF65-F5344CB8AC3E}">
        <p14:creationId xmlns:p14="http://schemas.microsoft.com/office/powerpoint/2010/main" val="2066887279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F13AB23C-247C-D434-DF3A-9ADC7D0E885C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662950" y="1089243"/>
            <a:ext cx="1789872" cy="2383628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3C45E1EE-B793-040B-8376-0091F9FCC9D8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93100" y="1095305"/>
            <a:ext cx="1772662" cy="2357813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EE6E1B28-5FF3-E9BC-95B6-74E2B8AD6233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2923722" y="1089243"/>
            <a:ext cx="1781267" cy="2357813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F2F5C22-AD53-ABBF-7169-1E455CA590B3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193100" y="3710709"/>
            <a:ext cx="1781267" cy="2357813"/>
          </a:xfrm>
          <a:prstGeom prst="rect">
            <a:avLst/>
          </a:prstGeom>
        </p:spPr>
      </p:pic>
      <p:pic>
        <p:nvPicPr>
          <p:cNvPr id="8" name="Picture 7">
            <a:extLst>
              <a:ext uri="{FF2B5EF4-FFF2-40B4-BE49-F238E27FC236}">
                <a16:creationId xmlns:a16="http://schemas.microsoft.com/office/drawing/2014/main" id="{8AEEEBBA-4B7E-4EEF-939E-3CEF25BB8EC7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983958" y="3710708"/>
            <a:ext cx="1721031" cy="2357813"/>
          </a:xfrm>
          <a:prstGeom prst="rect">
            <a:avLst/>
          </a:prstGeom>
        </p:spPr>
      </p:pic>
      <p:sp>
        <p:nvSpPr>
          <p:cNvPr id="9" name="TextBox 8">
            <a:extLst>
              <a:ext uri="{FF2B5EF4-FFF2-40B4-BE49-F238E27FC236}">
                <a16:creationId xmlns:a16="http://schemas.microsoft.com/office/drawing/2014/main" id="{16059D99-1ED9-F4E3-1C3B-745C359E6595}"/>
              </a:ext>
            </a:extLst>
          </p:cNvPr>
          <p:cNvSpPr txBox="1"/>
          <p:nvPr/>
        </p:nvSpPr>
        <p:spPr>
          <a:xfrm>
            <a:off x="551643" y="6611008"/>
            <a:ext cx="6669113" cy="954107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 dirty="0">
                <a:latin typeface="Times New Roman"/>
                <a:cs typeface="Times New Roman"/>
              </a:rPr>
              <a:t>Figure S5. Quantification of additional immune cell populations in Salmonella + Alb-IL2 treated mice. </a:t>
            </a:r>
            <a:r>
              <a:rPr lang="en-US" sz="1400" dirty="0">
                <a:latin typeface="Times New Roman"/>
                <a:cs typeface="Times New Roman"/>
              </a:rPr>
              <a:t>Lymphocytes from the blood were isolated two weeks after the initiation of treatment and analyzed using flow cytometry. Quantification of </a:t>
            </a:r>
            <a:r>
              <a:rPr lang="en-US" sz="1400" b="1" dirty="0">
                <a:latin typeface="Times New Roman"/>
                <a:cs typeface="Times New Roman"/>
              </a:rPr>
              <a:t>a)</a:t>
            </a:r>
            <a:r>
              <a:rPr lang="en-US" sz="1400" dirty="0">
                <a:latin typeface="Times New Roman"/>
                <a:cs typeface="Times New Roman"/>
              </a:rPr>
              <a:t> CD8+ CD44+ </a:t>
            </a:r>
            <a:r>
              <a:rPr lang="en-US" sz="1400" b="1" dirty="0">
                <a:latin typeface="Times New Roman"/>
                <a:cs typeface="Times New Roman"/>
              </a:rPr>
              <a:t>b)</a:t>
            </a:r>
            <a:r>
              <a:rPr lang="en-US" sz="1400" dirty="0">
                <a:latin typeface="Times New Roman"/>
                <a:cs typeface="Times New Roman"/>
              </a:rPr>
              <a:t> CD8+ Ki67+ </a:t>
            </a:r>
            <a:r>
              <a:rPr lang="en-US" sz="1400" b="1" dirty="0">
                <a:latin typeface="Times New Roman"/>
                <a:cs typeface="Times New Roman"/>
              </a:rPr>
              <a:t>c)</a:t>
            </a:r>
            <a:r>
              <a:rPr lang="en-US" sz="1400" dirty="0">
                <a:latin typeface="Times New Roman"/>
                <a:cs typeface="Times New Roman"/>
              </a:rPr>
              <a:t> CD8+ CD122+ </a:t>
            </a:r>
            <a:r>
              <a:rPr lang="en-US" sz="1400" b="1" dirty="0">
                <a:latin typeface="Times New Roman"/>
                <a:cs typeface="Times New Roman"/>
              </a:rPr>
              <a:t>d)</a:t>
            </a:r>
            <a:r>
              <a:rPr lang="en-US" sz="1400" dirty="0">
                <a:latin typeface="Times New Roman"/>
                <a:cs typeface="Times New Roman"/>
              </a:rPr>
              <a:t> CD4+ FoxP3+ and </a:t>
            </a:r>
            <a:r>
              <a:rPr lang="en-US" sz="1400" b="1" dirty="0">
                <a:latin typeface="Times New Roman"/>
                <a:cs typeface="Times New Roman"/>
              </a:rPr>
              <a:t>e)</a:t>
            </a:r>
            <a:r>
              <a:rPr lang="en-US" sz="1400" dirty="0">
                <a:latin typeface="Times New Roman"/>
                <a:cs typeface="Times New Roman"/>
              </a:rPr>
              <a:t> NK1.1+ NK Cells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08477702-1358-059A-56F4-764318E5A522}"/>
              </a:ext>
            </a:extLst>
          </p:cNvPr>
          <p:cNvSpPr txBox="1"/>
          <p:nvPr/>
        </p:nvSpPr>
        <p:spPr>
          <a:xfrm>
            <a:off x="825547" y="913904"/>
            <a:ext cx="362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836691CE-7D47-FD98-B5FD-85DDB05D32FE}"/>
              </a:ext>
            </a:extLst>
          </p:cNvPr>
          <p:cNvSpPr txBox="1"/>
          <p:nvPr/>
        </p:nvSpPr>
        <p:spPr>
          <a:xfrm>
            <a:off x="2947696" y="913904"/>
            <a:ext cx="362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/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D27D2774-0F6B-0D44-75EA-C35F15B81975}"/>
              </a:ext>
            </a:extLst>
          </p:cNvPr>
          <p:cNvSpPr txBox="1"/>
          <p:nvPr/>
        </p:nvSpPr>
        <p:spPr>
          <a:xfrm>
            <a:off x="4900881" y="913904"/>
            <a:ext cx="362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/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1D36DD20-65C8-CDF7-540F-2F91E3406A86}"/>
              </a:ext>
            </a:extLst>
          </p:cNvPr>
          <p:cNvSpPr txBox="1"/>
          <p:nvPr/>
        </p:nvSpPr>
        <p:spPr>
          <a:xfrm>
            <a:off x="825547" y="3454914"/>
            <a:ext cx="362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/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14E63C2C-31C1-A21D-B1A3-4AB3136B406B}"/>
              </a:ext>
            </a:extLst>
          </p:cNvPr>
          <p:cNvSpPr txBox="1"/>
          <p:nvPr/>
        </p:nvSpPr>
        <p:spPr>
          <a:xfrm>
            <a:off x="2947696" y="3454914"/>
            <a:ext cx="3627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sz="1600" b="1"/>
              <a:t>E</a:t>
            </a:r>
          </a:p>
        </p:txBody>
      </p:sp>
    </p:spTree>
    <p:extLst>
      <p:ext uri="{BB962C8B-B14F-4D97-AF65-F5344CB8AC3E}">
        <p14:creationId xmlns:p14="http://schemas.microsoft.com/office/powerpoint/2010/main" val="3571302438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>
            <a:extLst>
              <a:ext uri="{FF2B5EF4-FFF2-40B4-BE49-F238E27FC236}">
                <a16:creationId xmlns:a16="http://schemas.microsoft.com/office/drawing/2014/main" id="{2810DAAB-B671-1245-B6B0-4A299C4C17F2}"/>
              </a:ext>
            </a:extLst>
          </p:cNvPr>
          <p:cNvSpPr txBox="1"/>
          <p:nvPr/>
        </p:nvSpPr>
        <p:spPr>
          <a:xfrm>
            <a:off x="1327584" y="5551181"/>
            <a:ext cx="5117232" cy="1169551"/>
          </a:xfrm>
          <a:prstGeom prst="rect">
            <a:avLst/>
          </a:prstGeom>
          <a:noFill/>
        </p:spPr>
        <p:txBody>
          <a:bodyPr wrap="square" lIns="91440" tIns="45720" rIns="91440" bIns="45720" rtlCol="0" anchor="t">
            <a:spAutoFit/>
          </a:bodyPr>
          <a:lstStyle/>
          <a:p>
            <a:r>
              <a:rPr lang="en-US" sz="1400" b="1">
                <a:latin typeface="Times New Roman"/>
                <a:cs typeface="Times New Roman"/>
              </a:rPr>
              <a:t>Figure S6</a:t>
            </a:r>
            <a:r>
              <a:rPr lang="en-US" sz="1400" b="1" dirty="0">
                <a:latin typeface="Times New Roman"/>
                <a:cs typeface="Times New Roman"/>
              </a:rPr>
              <a:t>. Representative flow gating of T cell depletion. </a:t>
            </a:r>
            <a:r>
              <a:rPr lang="en-US" sz="1400" dirty="0">
                <a:latin typeface="Times New Roman"/>
                <a:cs typeface="Times New Roman"/>
              </a:rPr>
              <a:t>27 days post CT26 tumor inoculation in BALB/c mice,  3 doses of T cell depleting antibodies were administered. PBMCs were collected and stained for flow cytometric analysis. CD4 and CD8 T cell populations and gating strategy is shown. </a:t>
            </a:r>
            <a:endParaRPr lang="en-US" sz="14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2" name="Picture 1">
            <a:extLst>
              <a:ext uri="{FF2B5EF4-FFF2-40B4-BE49-F238E27FC236}">
                <a16:creationId xmlns:a16="http://schemas.microsoft.com/office/drawing/2014/main" id="{BEF8DEDA-89C6-D941-9A2B-97D1F0C8609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636703" y="1124692"/>
            <a:ext cx="6390639" cy="435107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3561028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2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/>
</p:properties>
</file>

<file path=customXml/item3.xml><?xml version="1.0" encoding="utf-8"?>
<ct:contentTypeSchema xmlns:ct="http://schemas.microsoft.com/office/2006/metadata/contentType" xmlns:ma="http://schemas.microsoft.com/office/2006/metadata/properties/metaAttributes" ct:_="" ma:_="" ma:contentTypeName="Document" ma:contentTypeID="0x01010023B66F0B3942F74B937B6DD082626EC9" ma:contentTypeVersion="8" ma:contentTypeDescription="Create a new document." ma:contentTypeScope="" ma:versionID="69655e218d64eb4bc0740d0b5e752251">
  <xsd:schema xmlns:xsd="http://www.w3.org/2001/XMLSchema" xmlns:xs="http://www.w3.org/2001/XMLSchema" xmlns:p="http://schemas.microsoft.com/office/2006/metadata/properties" xmlns:ns2="97640280-f263-4adf-bccc-6b5272cca7af" targetNamespace="http://schemas.microsoft.com/office/2006/metadata/properties" ma:root="true" ma:fieldsID="776a169e8353f077ae45c030e3058656" ns2:_="">
    <xsd:import namespace="97640280-f263-4adf-bccc-6b5272cca7af"/>
    <xsd:element name="properties">
      <xsd:complexType>
        <xsd:sequence>
          <xsd:element name="documentManagement">
            <xsd:complexType>
              <xsd:all>
                <xsd:element ref="ns2:MediaServiceMetadata" minOccurs="0"/>
                <xsd:element ref="ns2:MediaServiceFastMetadata" minOccurs="0"/>
                <xsd:element ref="ns2:MediaServiceAutoKeyPoints" minOccurs="0"/>
                <xsd:element ref="ns2:MediaServiceKeyPoints" minOccurs="0"/>
                <xsd:element ref="ns2:MediaServiceAutoTags" minOccurs="0"/>
                <xsd:element ref="ns2:MediaServiceOCR" minOccurs="0"/>
                <xsd:element ref="ns2:MediaServiceGenerationTime" minOccurs="0"/>
                <xsd:element ref="ns2:MediaServiceEventHashCode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7640280-f263-4adf-bccc-6b5272cca7af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8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9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0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1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AutoTags" ma:index="12" nillable="true" ma:displayName="Tags" ma:internalName="MediaServiceAutoTags" ma:readOnly="true">
      <xsd:simpleType>
        <xsd:restriction base="dms:Text"/>
      </xsd:simpleType>
    </xsd:element>
    <xsd:element name="MediaServiceOCR" ma:index="13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MediaServiceGenerationTime" ma:index="14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5" nillable="true" ma:displayName="MediaServiceEventHashCode" ma:hidden="true" ma:internalName="MediaServiceEventHashCode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Content Type"/>
        <xsd:element ref="dc:title" minOccurs="0" maxOccurs="1" ma:index="4" ma:displayName="Title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Props1.xml><?xml version="1.0" encoding="utf-8"?>
<ds:datastoreItem xmlns:ds="http://schemas.openxmlformats.org/officeDocument/2006/customXml" ds:itemID="{90B9DBBC-E7A8-4B3F-B825-57CB301EE044}">
  <ds:schemaRefs>
    <ds:schemaRef ds:uri="http://schemas.microsoft.com/sharepoint/v3/contenttype/forms"/>
  </ds:schemaRefs>
</ds:datastoreItem>
</file>

<file path=customXml/itemProps2.xml><?xml version="1.0" encoding="utf-8"?>
<ds:datastoreItem xmlns:ds="http://schemas.openxmlformats.org/officeDocument/2006/customXml" ds:itemID="{26E0DEA2-BDC8-4DFE-9B60-EBABA61FAA27}">
  <ds:schemaRefs>
    <ds:schemaRef ds:uri="http://schemas.microsoft.com/office/2006/metadata/properties"/>
    <ds:schemaRef ds:uri="http://schemas.microsoft.com/office/infopath/2007/PartnerControls"/>
  </ds:schemaRefs>
</ds:datastoreItem>
</file>

<file path=customXml/itemProps3.xml><?xml version="1.0" encoding="utf-8"?>
<ds:datastoreItem xmlns:ds="http://schemas.openxmlformats.org/officeDocument/2006/customXml" ds:itemID="{F72365A3-9A2B-4006-A199-4563BE132B8B}">
  <ds:schemaRefs>
    <ds:schemaRef ds:uri="97640280-f263-4adf-bccc-6b5272cca7af"/>
    <ds:schemaRef ds:uri="http://purl.org/dc/elements/1.1/"/>
    <ds:schemaRef ds:uri="http://purl.org/dc/terms/"/>
    <ds:schemaRef ds:uri="http://schemas.microsoft.com/internal/obd"/>
    <ds:schemaRef ds:uri="http://schemas.microsoft.com/office/2006/documentManagement/types"/>
    <ds:schemaRef ds:uri="http://schemas.microsoft.com/office/2006/metadata/contentType"/>
    <ds:schemaRef ds:uri="http://schemas.microsoft.com/office/2006/metadata/properties"/>
    <ds:schemaRef ds:uri="http://schemas.microsoft.com/office/2006/metadata/properties/metaAttributes"/>
    <ds:schemaRef ds:uri="http://schemas.microsoft.com/office/infopath/2007/PartnerControls"/>
    <ds:schemaRef ds:uri="http://schemas.openxmlformats.org/package/2006/metadata/core-properties"/>
    <ds:schemaRef ds:uri="http://www.w3.org/2001/XMLSchema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400</Words>
  <Application>Microsoft Office PowerPoint</Application>
  <PresentationFormat>Custom</PresentationFormat>
  <Paragraphs>14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2" baseType="lpstr">
      <vt:lpstr>Arial</vt:lpstr>
      <vt:lpstr>Calibri</vt:lpstr>
      <vt:lpstr>Calibri Light</vt:lpstr>
      <vt:lpstr>Helvetica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icrosoft Office User</dc:creator>
  <cp:lastModifiedBy>Victor,Maria Flora</cp:lastModifiedBy>
  <cp:revision>7</cp:revision>
  <dcterms:created xsi:type="dcterms:W3CDTF">2022-01-25T07:00:51Z</dcterms:created>
  <dcterms:modified xsi:type="dcterms:W3CDTF">2022-08-06T01:59:3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23B66F0B3942F74B937B6DD082626EC9</vt:lpwstr>
  </property>
</Properties>
</file>